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35999738" cy="21599525"/>
  <p:notesSz cx="6858000" cy="9144000"/>
  <p:defaultTextStyle>
    <a:defPPr>
      <a:defRPr lang="es-ES"/>
    </a:defPPr>
    <a:lvl1pPr marL="0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1pPr>
    <a:lvl2pPr marL="1382344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2pPr>
    <a:lvl3pPr marL="2764688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3pPr>
    <a:lvl4pPr marL="4147033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4pPr>
    <a:lvl5pPr marL="5529377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5pPr>
    <a:lvl6pPr marL="6911721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6pPr>
    <a:lvl7pPr marL="8294065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7pPr>
    <a:lvl8pPr marL="9676409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8pPr>
    <a:lvl9pPr marL="11058754" algn="l" defTabSz="2764688" rtl="0" eaLnBrk="1" latinLnBrk="0" hangingPunct="1">
      <a:defRPr sz="544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 García Higarza" initials="SGH" lastIdx="1" clrIdx="0">
    <p:extLst>
      <p:ext uri="{19B8F6BF-5375-455C-9EA6-DF929625EA0E}">
        <p15:presenceInfo xmlns:p15="http://schemas.microsoft.com/office/powerpoint/2012/main" userId="77929bb328d1cf7d" providerId="Windows Live"/>
      </p:ext>
    </p:extLst>
  </p:cmAuthor>
  <p:cmAuthor id="2" name="Sara García Higarza" initials="SGH [2]" lastIdx="1" clrIdx="1">
    <p:extLst>
      <p:ext uri="{19B8F6BF-5375-455C-9EA6-DF929625EA0E}">
        <p15:presenceInfo xmlns:p15="http://schemas.microsoft.com/office/powerpoint/2012/main" userId="Sara García Higarz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D4D4D"/>
    <a:srgbClr val="777777"/>
    <a:srgbClr val="808080"/>
    <a:srgbClr val="B2B2B2"/>
    <a:srgbClr val="292929"/>
    <a:srgbClr val="1C1C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805" autoAdjust="0"/>
  </p:normalViewPr>
  <p:slideViewPr>
    <p:cSldViewPr snapToGrid="0">
      <p:cViewPr varScale="1">
        <p:scale>
          <a:sx n="20" d="100"/>
          <a:sy n="20" d="100"/>
        </p:scale>
        <p:origin x="115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7013B0-51A4-45F1-9B15-F40F486F309A}" type="datetimeFigureOut">
              <a:rPr lang="es-ES" smtClean="0"/>
              <a:t>14/07/2022</a:t>
            </a:fld>
            <a:endParaRPr lang="es-ES" dirty="0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1143000"/>
            <a:ext cx="51435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 dirty="0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9F3696-06D2-484C-9292-C79CE46459A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99876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4499967" y="3534924"/>
            <a:ext cx="26999804" cy="7519835"/>
          </a:xfrm>
        </p:spPr>
        <p:txBody>
          <a:bodyPr anchor="b"/>
          <a:lstStyle>
            <a:lvl1pPr algn="ctr">
              <a:defRPr sz="1771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4499967" y="11344752"/>
            <a:ext cx="26999804" cy="5214884"/>
          </a:xfrm>
        </p:spPr>
        <p:txBody>
          <a:bodyPr/>
          <a:lstStyle>
            <a:lvl1pPr marL="0" indent="0" algn="ctr">
              <a:buNone/>
              <a:defRPr sz="7086"/>
            </a:lvl1pPr>
            <a:lvl2pPr marL="1349974" indent="0" algn="ctr">
              <a:buNone/>
              <a:defRPr sz="5905"/>
            </a:lvl2pPr>
            <a:lvl3pPr marL="2699949" indent="0" algn="ctr">
              <a:buNone/>
              <a:defRPr sz="5315"/>
            </a:lvl3pPr>
            <a:lvl4pPr marL="4049923" indent="0" algn="ctr">
              <a:buNone/>
              <a:defRPr sz="4724"/>
            </a:lvl4pPr>
            <a:lvl5pPr marL="5399898" indent="0" algn="ctr">
              <a:buNone/>
              <a:defRPr sz="4724"/>
            </a:lvl5pPr>
            <a:lvl6pPr marL="6749872" indent="0" algn="ctr">
              <a:buNone/>
              <a:defRPr sz="4724"/>
            </a:lvl6pPr>
            <a:lvl7pPr marL="8099847" indent="0" algn="ctr">
              <a:buNone/>
              <a:defRPr sz="4724"/>
            </a:lvl7pPr>
            <a:lvl8pPr marL="9449821" indent="0" algn="ctr">
              <a:buNone/>
              <a:defRPr sz="4724"/>
            </a:lvl8pPr>
            <a:lvl9pPr marL="10799796" indent="0" algn="ctr">
              <a:buNone/>
              <a:defRPr sz="4724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0365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2484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25762312" y="1149975"/>
            <a:ext cx="7762444" cy="18304599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474982" y="1149975"/>
            <a:ext cx="22837334" cy="18304599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6973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0770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2456232" y="5384885"/>
            <a:ext cx="31049774" cy="8984801"/>
          </a:xfrm>
        </p:spPr>
        <p:txBody>
          <a:bodyPr anchor="b"/>
          <a:lstStyle>
            <a:lvl1pPr>
              <a:defRPr sz="1771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2456232" y="14454685"/>
            <a:ext cx="31049774" cy="4724895"/>
          </a:xfrm>
        </p:spPr>
        <p:txBody>
          <a:bodyPr/>
          <a:lstStyle>
            <a:lvl1pPr marL="0" indent="0">
              <a:buNone/>
              <a:defRPr sz="7086">
                <a:solidFill>
                  <a:schemeClr val="tx1">
                    <a:tint val="75000"/>
                  </a:schemeClr>
                </a:solidFill>
              </a:defRPr>
            </a:lvl1pPr>
            <a:lvl2pPr marL="1349974" indent="0">
              <a:buNone/>
              <a:defRPr sz="5905">
                <a:solidFill>
                  <a:schemeClr val="tx1">
                    <a:tint val="75000"/>
                  </a:schemeClr>
                </a:solidFill>
              </a:defRPr>
            </a:lvl2pPr>
            <a:lvl3pPr marL="2699949" indent="0">
              <a:buNone/>
              <a:defRPr sz="5315">
                <a:solidFill>
                  <a:schemeClr val="tx1">
                    <a:tint val="75000"/>
                  </a:schemeClr>
                </a:solidFill>
              </a:defRPr>
            </a:lvl3pPr>
            <a:lvl4pPr marL="4049923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4pPr>
            <a:lvl5pPr marL="5399898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5pPr>
            <a:lvl6pPr marL="6749872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6pPr>
            <a:lvl7pPr marL="8099847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7pPr>
            <a:lvl8pPr marL="9449821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8pPr>
            <a:lvl9pPr marL="10799796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9608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474982" y="5749874"/>
            <a:ext cx="15299889" cy="13704700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18224867" y="5749874"/>
            <a:ext cx="15299889" cy="13704700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89942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2479671" y="1149976"/>
            <a:ext cx="31049774" cy="417491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2479672" y="5294885"/>
            <a:ext cx="15229575" cy="2594941"/>
          </a:xfrm>
        </p:spPr>
        <p:txBody>
          <a:bodyPr anchor="b"/>
          <a:lstStyle>
            <a:lvl1pPr marL="0" indent="0">
              <a:buNone/>
              <a:defRPr sz="7086" b="1"/>
            </a:lvl1pPr>
            <a:lvl2pPr marL="1349974" indent="0">
              <a:buNone/>
              <a:defRPr sz="5905" b="1"/>
            </a:lvl2pPr>
            <a:lvl3pPr marL="2699949" indent="0">
              <a:buNone/>
              <a:defRPr sz="5315" b="1"/>
            </a:lvl3pPr>
            <a:lvl4pPr marL="4049923" indent="0">
              <a:buNone/>
              <a:defRPr sz="4724" b="1"/>
            </a:lvl4pPr>
            <a:lvl5pPr marL="5399898" indent="0">
              <a:buNone/>
              <a:defRPr sz="4724" b="1"/>
            </a:lvl5pPr>
            <a:lvl6pPr marL="6749872" indent="0">
              <a:buNone/>
              <a:defRPr sz="4724" b="1"/>
            </a:lvl6pPr>
            <a:lvl7pPr marL="8099847" indent="0">
              <a:buNone/>
              <a:defRPr sz="4724" b="1"/>
            </a:lvl7pPr>
            <a:lvl8pPr marL="9449821" indent="0">
              <a:buNone/>
              <a:defRPr sz="4724" b="1"/>
            </a:lvl8pPr>
            <a:lvl9pPr marL="10799796" indent="0">
              <a:buNone/>
              <a:defRPr sz="4724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479672" y="7889827"/>
            <a:ext cx="15229575" cy="1160474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18224867" y="5294885"/>
            <a:ext cx="15304578" cy="2594941"/>
          </a:xfrm>
        </p:spPr>
        <p:txBody>
          <a:bodyPr anchor="b"/>
          <a:lstStyle>
            <a:lvl1pPr marL="0" indent="0">
              <a:buNone/>
              <a:defRPr sz="7086" b="1"/>
            </a:lvl1pPr>
            <a:lvl2pPr marL="1349974" indent="0">
              <a:buNone/>
              <a:defRPr sz="5905" b="1"/>
            </a:lvl2pPr>
            <a:lvl3pPr marL="2699949" indent="0">
              <a:buNone/>
              <a:defRPr sz="5315" b="1"/>
            </a:lvl3pPr>
            <a:lvl4pPr marL="4049923" indent="0">
              <a:buNone/>
              <a:defRPr sz="4724" b="1"/>
            </a:lvl4pPr>
            <a:lvl5pPr marL="5399898" indent="0">
              <a:buNone/>
              <a:defRPr sz="4724" b="1"/>
            </a:lvl5pPr>
            <a:lvl6pPr marL="6749872" indent="0">
              <a:buNone/>
              <a:defRPr sz="4724" b="1"/>
            </a:lvl6pPr>
            <a:lvl7pPr marL="8099847" indent="0">
              <a:buNone/>
              <a:defRPr sz="4724" b="1"/>
            </a:lvl7pPr>
            <a:lvl8pPr marL="9449821" indent="0">
              <a:buNone/>
              <a:defRPr sz="4724" b="1"/>
            </a:lvl8pPr>
            <a:lvl9pPr marL="10799796" indent="0">
              <a:buNone/>
              <a:defRPr sz="4724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18224867" y="7889827"/>
            <a:ext cx="15304578" cy="1160474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9884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1380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8672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2479672" y="1439968"/>
            <a:ext cx="11610852" cy="5039889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15304578" y="3109933"/>
            <a:ext cx="18224867" cy="15349662"/>
          </a:xfrm>
        </p:spPr>
        <p:txBody>
          <a:bodyPr/>
          <a:lstStyle>
            <a:lvl1pPr>
              <a:defRPr sz="9449"/>
            </a:lvl1pPr>
            <a:lvl2pPr>
              <a:defRPr sz="8268"/>
            </a:lvl2pPr>
            <a:lvl3pPr>
              <a:defRPr sz="7086"/>
            </a:lvl3pPr>
            <a:lvl4pPr>
              <a:defRPr sz="5905"/>
            </a:lvl4pPr>
            <a:lvl5pPr>
              <a:defRPr sz="5905"/>
            </a:lvl5pPr>
            <a:lvl6pPr>
              <a:defRPr sz="5905"/>
            </a:lvl6pPr>
            <a:lvl7pPr>
              <a:defRPr sz="5905"/>
            </a:lvl7pPr>
            <a:lvl8pPr>
              <a:defRPr sz="5905"/>
            </a:lvl8pPr>
            <a:lvl9pPr>
              <a:defRPr sz="5905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2479672" y="6479857"/>
            <a:ext cx="11610852" cy="12004738"/>
          </a:xfrm>
        </p:spPr>
        <p:txBody>
          <a:bodyPr/>
          <a:lstStyle>
            <a:lvl1pPr marL="0" indent="0">
              <a:buNone/>
              <a:defRPr sz="4724"/>
            </a:lvl1pPr>
            <a:lvl2pPr marL="1349974" indent="0">
              <a:buNone/>
              <a:defRPr sz="4134"/>
            </a:lvl2pPr>
            <a:lvl3pPr marL="2699949" indent="0">
              <a:buNone/>
              <a:defRPr sz="3543"/>
            </a:lvl3pPr>
            <a:lvl4pPr marL="4049923" indent="0">
              <a:buNone/>
              <a:defRPr sz="2953"/>
            </a:lvl4pPr>
            <a:lvl5pPr marL="5399898" indent="0">
              <a:buNone/>
              <a:defRPr sz="2953"/>
            </a:lvl5pPr>
            <a:lvl6pPr marL="6749872" indent="0">
              <a:buNone/>
              <a:defRPr sz="2953"/>
            </a:lvl6pPr>
            <a:lvl7pPr marL="8099847" indent="0">
              <a:buNone/>
              <a:defRPr sz="2953"/>
            </a:lvl7pPr>
            <a:lvl8pPr marL="9449821" indent="0">
              <a:buNone/>
              <a:defRPr sz="2953"/>
            </a:lvl8pPr>
            <a:lvl9pPr marL="10799796" indent="0">
              <a:buNone/>
              <a:defRPr sz="295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25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2479672" y="1439968"/>
            <a:ext cx="11610852" cy="5039889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5304578" y="3109933"/>
            <a:ext cx="18224867" cy="15349662"/>
          </a:xfrm>
        </p:spPr>
        <p:txBody>
          <a:bodyPr/>
          <a:lstStyle>
            <a:lvl1pPr marL="0" indent="0">
              <a:buNone/>
              <a:defRPr sz="9449"/>
            </a:lvl1pPr>
            <a:lvl2pPr marL="1349974" indent="0">
              <a:buNone/>
              <a:defRPr sz="8268"/>
            </a:lvl2pPr>
            <a:lvl3pPr marL="2699949" indent="0">
              <a:buNone/>
              <a:defRPr sz="7086"/>
            </a:lvl3pPr>
            <a:lvl4pPr marL="4049923" indent="0">
              <a:buNone/>
              <a:defRPr sz="5905"/>
            </a:lvl4pPr>
            <a:lvl5pPr marL="5399898" indent="0">
              <a:buNone/>
              <a:defRPr sz="5905"/>
            </a:lvl5pPr>
            <a:lvl6pPr marL="6749872" indent="0">
              <a:buNone/>
              <a:defRPr sz="5905"/>
            </a:lvl6pPr>
            <a:lvl7pPr marL="8099847" indent="0">
              <a:buNone/>
              <a:defRPr sz="5905"/>
            </a:lvl7pPr>
            <a:lvl8pPr marL="9449821" indent="0">
              <a:buNone/>
              <a:defRPr sz="5905"/>
            </a:lvl8pPr>
            <a:lvl9pPr marL="10799796" indent="0">
              <a:buNone/>
              <a:defRPr sz="5905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2479672" y="6479857"/>
            <a:ext cx="11610852" cy="12004738"/>
          </a:xfrm>
        </p:spPr>
        <p:txBody>
          <a:bodyPr/>
          <a:lstStyle>
            <a:lvl1pPr marL="0" indent="0">
              <a:buNone/>
              <a:defRPr sz="4724"/>
            </a:lvl1pPr>
            <a:lvl2pPr marL="1349974" indent="0">
              <a:buNone/>
              <a:defRPr sz="4134"/>
            </a:lvl2pPr>
            <a:lvl3pPr marL="2699949" indent="0">
              <a:buNone/>
              <a:defRPr sz="3543"/>
            </a:lvl3pPr>
            <a:lvl4pPr marL="4049923" indent="0">
              <a:buNone/>
              <a:defRPr sz="2953"/>
            </a:lvl4pPr>
            <a:lvl5pPr marL="5399898" indent="0">
              <a:buNone/>
              <a:defRPr sz="2953"/>
            </a:lvl5pPr>
            <a:lvl6pPr marL="6749872" indent="0">
              <a:buNone/>
              <a:defRPr sz="2953"/>
            </a:lvl6pPr>
            <a:lvl7pPr marL="8099847" indent="0">
              <a:buNone/>
              <a:defRPr sz="2953"/>
            </a:lvl7pPr>
            <a:lvl8pPr marL="9449821" indent="0">
              <a:buNone/>
              <a:defRPr sz="2953"/>
            </a:lvl8pPr>
            <a:lvl9pPr marL="10799796" indent="0">
              <a:buNone/>
              <a:defRPr sz="295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4853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2474982" y="1149976"/>
            <a:ext cx="31049774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2474982" y="5749874"/>
            <a:ext cx="31049774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2474982" y="20019561"/>
            <a:ext cx="8099941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5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FBE46-7FD3-4EBD-852C-2A5A0618631E}" type="datetimeFigureOut">
              <a:rPr lang="es-ES" smtClean="0"/>
              <a:t>1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11924913" y="20019561"/>
            <a:ext cx="12149912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5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25424815" y="20019561"/>
            <a:ext cx="8099941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5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A257C8-DB18-4C60-AC95-870FCDD11FE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7575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699949" rtl="0" eaLnBrk="1" latinLnBrk="0" hangingPunct="1">
        <a:lnSpc>
          <a:spcPct val="90000"/>
        </a:lnSpc>
        <a:spcBef>
          <a:spcPct val="0"/>
        </a:spcBef>
        <a:buNone/>
        <a:defRPr sz="1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74987" indent="-674987" algn="l" defTabSz="2699949" rtl="0" eaLnBrk="1" latinLnBrk="0" hangingPunct="1">
        <a:lnSpc>
          <a:spcPct val="90000"/>
        </a:lnSpc>
        <a:spcBef>
          <a:spcPts val="2953"/>
        </a:spcBef>
        <a:buFont typeface="Arial" panose="020B0604020202020204" pitchFamily="34" charset="0"/>
        <a:buChar char="•"/>
        <a:defRPr sz="8268" kern="1200">
          <a:solidFill>
            <a:schemeClr val="tx1"/>
          </a:solidFill>
          <a:latin typeface="+mn-lt"/>
          <a:ea typeface="+mn-ea"/>
          <a:cs typeface="+mn-cs"/>
        </a:defRPr>
      </a:lvl1pPr>
      <a:lvl2pPr marL="2024962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7086" kern="1200">
          <a:solidFill>
            <a:schemeClr val="tx1"/>
          </a:solidFill>
          <a:latin typeface="+mn-lt"/>
          <a:ea typeface="+mn-ea"/>
          <a:cs typeface="+mn-cs"/>
        </a:defRPr>
      </a:lvl2pPr>
      <a:lvl3pPr marL="3374936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5905" kern="1200">
          <a:solidFill>
            <a:schemeClr val="tx1"/>
          </a:solidFill>
          <a:latin typeface="+mn-lt"/>
          <a:ea typeface="+mn-ea"/>
          <a:cs typeface="+mn-cs"/>
        </a:defRPr>
      </a:lvl3pPr>
      <a:lvl4pPr marL="4724911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5315" kern="1200">
          <a:solidFill>
            <a:schemeClr val="tx1"/>
          </a:solidFill>
          <a:latin typeface="+mn-lt"/>
          <a:ea typeface="+mn-ea"/>
          <a:cs typeface="+mn-cs"/>
        </a:defRPr>
      </a:lvl4pPr>
      <a:lvl5pPr marL="6074885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5315" kern="1200">
          <a:solidFill>
            <a:schemeClr val="tx1"/>
          </a:solidFill>
          <a:latin typeface="+mn-lt"/>
          <a:ea typeface="+mn-ea"/>
          <a:cs typeface="+mn-cs"/>
        </a:defRPr>
      </a:lvl5pPr>
      <a:lvl6pPr marL="7424859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5315" kern="1200">
          <a:solidFill>
            <a:schemeClr val="tx1"/>
          </a:solidFill>
          <a:latin typeface="+mn-lt"/>
          <a:ea typeface="+mn-ea"/>
          <a:cs typeface="+mn-cs"/>
        </a:defRPr>
      </a:lvl6pPr>
      <a:lvl7pPr marL="8774834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5315" kern="1200">
          <a:solidFill>
            <a:schemeClr val="tx1"/>
          </a:solidFill>
          <a:latin typeface="+mn-lt"/>
          <a:ea typeface="+mn-ea"/>
          <a:cs typeface="+mn-cs"/>
        </a:defRPr>
      </a:lvl7pPr>
      <a:lvl8pPr marL="10124808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5315" kern="1200">
          <a:solidFill>
            <a:schemeClr val="tx1"/>
          </a:solidFill>
          <a:latin typeface="+mn-lt"/>
          <a:ea typeface="+mn-ea"/>
          <a:cs typeface="+mn-cs"/>
        </a:defRPr>
      </a:lvl8pPr>
      <a:lvl9pPr marL="11474783" indent="-674987" algn="l" defTabSz="2699949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53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1pPr>
      <a:lvl2pPr marL="1349974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2pPr>
      <a:lvl3pPr marL="2699949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3pPr>
      <a:lvl4pPr marL="4049923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4pPr>
      <a:lvl5pPr marL="5399898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5pPr>
      <a:lvl6pPr marL="6749872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6pPr>
      <a:lvl7pPr marL="8099847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7pPr>
      <a:lvl8pPr marL="9449821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8pPr>
      <a:lvl9pPr marL="10799796" algn="l" defTabSz="2699949" rtl="0" eaLnBrk="1" latinLnBrk="0" hangingPunct="1">
        <a:defRPr sz="53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558485" y="18499945"/>
            <a:ext cx="3488276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2699949"/>
            <a:r>
              <a:rPr lang="es-ES" sz="48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4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gure 1:</a:t>
            </a:r>
            <a:r>
              <a:rPr lang="es-ES" sz="4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en-US" sz="4800" b="1" dirty="0">
                <a:latin typeface="Arial" panose="020B0604020202020204" pitchFamily="34" charset="0"/>
                <a:cs typeface="Arial" panose="020B0604020202020204" pitchFamily="34" charset="0"/>
              </a:rPr>
              <a:t>Gut microbiota differences by pairwise comparison</a:t>
            </a:r>
            <a:r>
              <a:rPr lang="en-US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. Results of </a:t>
            </a:r>
            <a:r>
              <a:rPr lang="en-US" altLang="en-US" sz="4800" dirty="0" err="1">
                <a:latin typeface="Arial" panose="020B0604020202020204" pitchFamily="34" charset="0"/>
                <a:cs typeface="Arial" panose="020B0604020202020204" pitchFamily="34" charset="0"/>
              </a:rPr>
              <a:t>LEfSe</a:t>
            </a:r>
            <a:r>
              <a:rPr lang="en-US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analysis </a:t>
            </a:r>
            <a:r>
              <a:rPr lang="en-US" sz="4800" dirty="0">
                <a:latin typeface="Arial" panose="020B0604020202020204" pitchFamily="34" charset="0"/>
                <a:cs typeface="Arial" panose="020B0604020202020204" pitchFamily="34" charset="0"/>
              </a:rPr>
              <a:t>(LDA scores &gt; 2 and significance of </a:t>
            </a:r>
            <a:r>
              <a:rPr lang="en-US" sz="4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4800" dirty="0">
                <a:latin typeface="Arial" panose="020B0604020202020204" pitchFamily="34" charset="0"/>
                <a:cs typeface="Arial" panose="020B0604020202020204" pitchFamily="34" charset="0"/>
              </a:rPr>
              <a:t>&lt;0.05 as determined by Wilcoxon’s signed-rank test)</a:t>
            </a:r>
            <a:r>
              <a:rPr lang="en-US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showing discriminant taxa among </a:t>
            </a:r>
            <a:r>
              <a:rPr lang="en-US" altLang="en-US" sz="48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NC vs NC+TAA groups, </a:t>
            </a:r>
            <a:r>
              <a:rPr lang="en-US" altLang="en-US" sz="48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HFHC vs HFHC+TAA experimental groups and </a:t>
            </a:r>
            <a:r>
              <a:rPr lang="en-US" altLang="en-US" sz="48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HC+TAA and HFHC+TAA groups. Red indicates high LDA score and blue low LDA score between groups. </a:t>
            </a:r>
            <a:endParaRPr lang="es-ES" sz="4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7">
            <a:extLst>
              <a:ext uri="{FF2B5EF4-FFF2-40B4-BE49-F238E27FC236}">
                <a16:creationId xmlns:a16="http://schemas.microsoft.com/office/drawing/2014/main" id="{BD5366A4-A700-3776-E4CB-D518CC3A74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41803"/>
            <a:ext cx="6300000" cy="2263016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B796F0DC-CE50-9958-3678-A7996A868CB3}"/>
              </a:ext>
            </a:extLst>
          </p:cNvPr>
          <p:cNvSpPr txBox="1"/>
          <p:nvPr/>
        </p:nvSpPr>
        <p:spPr>
          <a:xfrm>
            <a:off x="12306981" y="830513"/>
            <a:ext cx="1138577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Material</a:t>
            </a:r>
            <a:endParaRPr lang="es-ES" sz="8000" b="1" i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30485E30-864B-0CDD-799E-4A5E65D31F99}"/>
              </a:ext>
            </a:extLst>
          </p:cNvPr>
          <p:cNvGrpSpPr/>
          <p:nvPr/>
        </p:nvGrpSpPr>
        <p:grpSpPr>
          <a:xfrm>
            <a:off x="885718" y="1492232"/>
            <a:ext cx="33704347" cy="17180467"/>
            <a:chOff x="885718" y="1492232"/>
            <a:chExt cx="33704347" cy="17180467"/>
          </a:xfrm>
        </p:grpSpPr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A10E8FAB-DECD-04F1-E80C-275B053598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85718" y="1885936"/>
              <a:ext cx="16920000" cy="6686648"/>
            </a:xfrm>
            <a:prstGeom prst="rect">
              <a:avLst/>
            </a:prstGeom>
          </p:spPr>
        </p:pic>
        <p:grpSp>
          <p:nvGrpSpPr>
            <p:cNvPr id="14" name="Grupo 13">
              <a:extLst>
                <a:ext uri="{FF2B5EF4-FFF2-40B4-BE49-F238E27FC236}">
                  <a16:creationId xmlns:a16="http://schemas.microsoft.com/office/drawing/2014/main" id="{4D82FD29-621A-BE68-446B-83EEFE064B2E}"/>
                </a:ext>
              </a:extLst>
            </p:cNvPr>
            <p:cNvGrpSpPr/>
            <p:nvPr/>
          </p:nvGrpSpPr>
          <p:grpSpPr>
            <a:xfrm>
              <a:off x="1589440" y="1492232"/>
              <a:ext cx="33000625" cy="17180467"/>
              <a:chOff x="1589440" y="1492232"/>
              <a:chExt cx="33000625" cy="17180467"/>
            </a:xfrm>
          </p:grpSpPr>
          <p:pic>
            <p:nvPicPr>
              <p:cNvPr id="28" name="Imagen 27">
                <a:extLst>
                  <a:ext uri="{FF2B5EF4-FFF2-40B4-BE49-F238E27FC236}">
                    <a16:creationId xmlns:a16="http://schemas.microsoft.com/office/drawing/2014/main" id="{57388DE3-8DD8-8432-441A-45D5C7893A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tretch>
                <a:fillRect/>
              </a:stretch>
            </p:blipFill>
            <p:spPr>
              <a:xfrm>
                <a:off x="1605718" y="7882069"/>
                <a:ext cx="16200000" cy="10617876"/>
              </a:xfrm>
              <a:prstGeom prst="rect">
                <a:avLst/>
              </a:prstGeom>
            </p:spPr>
          </p:pic>
          <p:pic>
            <p:nvPicPr>
              <p:cNvPr id="30" name="Imagen 29">
                <a:extLst>
                  <a:ext uri="{FF2B5EF4-FFF2-40B4-BE49-F238E27FC236}">
                    <a16:creationId xmlns:a16="http://schemas.microsoft.com/office/drawing/2014/main" id="{585196B8-3394-D2AA-39A6-B647CB5D8E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1630065" y="1492232"/>
                <a:ext cx="12960000" cy="17180467"/>
              </a:xfrm>
              <a:prstGeom prst="rect">
                <a:avLst/>
              </a:prstGeom>
            </p:spPr>
          </p:pic>
          <p:sp>
            <p:nvSpPr>
              <p:cNvPr id="38" name="CuadroTexto 37">
                <a:extLst>
                  <a:ext uri="{FF2B5EF4-FFF2-40B4-BE49-F238E27FC236}">
                    <a16:creationId xmlns:a16="http://schemas.microsoft.com/office/drawing/2014/main" id="{9F4549A0-5D2C-757B-C122-89A37E8B1418}"/>
                  </a:ext>
                </a:extLst>
              </p:cNvPr>
              <p:cNvSpPr txBox="1"/>
              <p:nvPr/>
            </p:nvSpPr>
            <p:spPr>
              <a:xfrm>
                <a:off x="17377951" y="6752612"/>
                <a:ext cx="5143911" cy="255454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just" defTabSz="2699949"/>
                <a:r>
                  <a:rPr lang="es-ES" sz="4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C – </a:t>
                </a:r>
                <a:r>
                  <a:rPr lang="es-ES" sz="4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oup1</a:t>
                </a:r>
              </a:p>
              <a:p>
                <a:pPr algn="just" defTabSz="2699949"/>
                <a:r>
                  <a:rPr lang="es-ES" sz="4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HC – </a:t>
                </a:r>
                <a:r>
                  <a:rPr lang="es-ES" sz="4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oup2</a:t>
                </a:r>
              </a:p>
              <a:p>
                <a:pPr algn="just" defTabSz="2699949"/>
                <a:r>
                  <a:rPr lang="es-ES" sz="4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C+TAA – </a:t>
                </a:r>
                <a:r>
                  <a:rPr lang="es-ES" sz="4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oup3</a:t>
                </a:r>
              </a:p>
              <a:p>
                <a:pPr algn="just" defTabSz="2699949"/>
                <a:r>
                  <a:rPr lang="es-ES" sz="4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HC+TAA – </a:t>
                </a:r>
                <a:r>
                  <a:rPr lang="es-ES" sz="4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oup4</a:t>
                </a:r>
              </a:p>
            </p:txBody>
          </p:sp>
          <p:sp>
            <p:nvSpPr>
              <p:cNvPr id="39" name="CuadroTexto 38">
                <a:extLst>
                  <a:ext uri="{FF2B5EF4-FFF2-40B4-BE49-F238E27FC236}">
                    <a16:creationId xmlns:a16="http://schemas.microsoft.com/office/drawing/2014/main" id="{0B62350B-9EB4-3731-0D37-CAD28A3CDF5D}"/>
                  </a:ext>
                </a:extLst>
              </p:cNvPr>
              <p:cNvSpPr txBox="1"/>
              <p:nvPr/>
            </p:nvSpPr>
            <p:spPr>
              <a:xfrm>
                <a:off x="1589440" y="2242372"/>
                <a:ext cx="842588" cy="85720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defTabSz="2699949"/>
                <a:r>
                  <a:rPr lang="es-ES" sz="54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40" name="CuadroTexto 39">
                <a:extLst>
                  <a:ext uri="{FF2B5EF4-FFF2-40B4-BE49-F238E27FC236}">
                    <a16:creationId xmlns:a16="http://schemas.microsoft.com/office/drawing/2014/main" id="{A9C3C632-3EA4-1E5B-18B1-1DA725CCC094}"/>
                  </a:ext>
                </a:extLst>
              </p:cNvPr>
              <p:cNvSpPr txBox="1"/>
              <p:nvPr/>
            </p:nvSpPr>
            <p:spPr>
              <a:xfrm>
                <a:off x="2307412" y="8383826"/>
                <a:ext cx="842588" cy="92333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defTabSz="2699949"/>
                <a:r>
                  <a:rPr lang="es-ES" sz="54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41" name="CuadroTexto 40">
                <a:extLst>
                  <a:ext uri="{FF2B5EF4-FFF2-40B4-BE49-F238E27FC236}">
                    <a16:creationId xmlns:a16="http://schemas.microsoft.com/office/drawing/2014/main" id="{03658203-559B-6F21-1219-900E420593BA}"/>
                  </a:ext>
                </a:extLst>
              </p:cNvPr>
              <p:cNvSpPr txBox="1"/>
              <p:nvPr/>
            </p:nvSpPr>
            <p:spPr>
              <a:xfrm>
                <a:off x="22850168" y="2036207"/>
                <a:ext cx="842588" cy="92333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defTabSz="2699949"/>
                <a:r>
                  <a:rPr lang="es-ES" sz="54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53512032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6</TotalTime>
  <Words>104</Words>
  <Application>Microsoft Office PowerPoint</Application>
  <PresentationFormat>Personalizado</PresentationFormat>
  <Paragraphs>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ra García Higarza</dc:creator>
  <cp:lastModifiedBy>Natalia Arias del Castillo</cp:lastModifiedBy>
  <cp:revision>70</cp:revision>
  <dcterms:created xsi:type="dcterms:W3CDTF">2020-05-13T11:22:47Z</dcterms:created>
  <dcterms:modified xsi:type="dcterms:W3CDTF">2022-07-14T15:37:49Z</dcterms:modified>
</cp:coreProperties>
</file>